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51450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4F932E-ACF8-4EA7-A07A-1BBB9E5C0F6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206280"/>
            <a:ext cx="61722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1200240"/>
            <a:ext cx="61722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2973240"/>
            <a:ext cx="61722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82FF89-C8F3-4BC9-B922-FD639996C4E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206280"/>
            <a:ext cx="61722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1200240"/>
            <a:ext cx="301176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1200240"/>
            <a:ext cx="301176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2973240"/>
            <a:ext cx="301176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2973240"/>
            <a:ext cx="301176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FB842F-728D-47DD-9E3A-E2FCACA4414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206280"/>
            <a:ext cx="61722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1200240"/>
            <a:ext cx="19872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1200240"/>
            <a:ext cx="19872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1200240"/>
            <a:ext cx="19872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2973240"/>
            <a:ext cx="19872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2973240"/>
            <a:ext cx="19872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2973240"/>
            <a:ext cx="19872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F3D630-C9C5-4C30-93F4-28C4ABA00BA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206280"/>
            <a:ext cx="61722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1200240"/>
            <a:ext cx="6172200" cy="3394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01"/>
              </a:spcBef>
              <a:buNone/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C6BA56-BE07-4CD9-A31D-C8664C8BAD1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206280"/>
            <a:ext cx="61722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1200240"/>
            <a:ext cx="6172200" cy="339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CD0EA2-3533-4EC5-91BB-CB5BC1C3CEE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206280"/>
            <a:ext cx="61722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1200240"/>
            <a:ext cx="3011760" cy="339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1200240"/>
            <a:ext cx="3011760" cy="339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06CE7B-220D-4E3B-A3ED-C4EBF87B384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206280"/>
            <a:ext cx="61722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14885C-26A5-436A-9BB0-56B8C694AB2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206280"/>
            <a:ext cx="6172200" cy="3976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01"/>
              </a:spcBef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6307B1-7F1C-4763-9763-5EFD20A7E42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206280"/>
            <a:ext cx="61722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1200240"/>
            <a:ext cx="301176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1200240"/>
            <a:ext cx="3011760" cy="339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2973240"/>
            <a:ext cx="301176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6D6965-6145-4FBF-AD00-002765F196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206280"/>
            <a:ext cx="61722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1200240"/>
            <a:ext cx="3011760" cy="339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1200240"/>
            <a:ext cx="301176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2973240"/>
            <a:ext cx="301176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50E6A2-3798-46F5-8F02-24D419EDDD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206280"/>
            <a:ext cx="61722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1200240"/>
            <a:ext cx="301176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1200240"/>
            <a:ext cx="301176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2973240"/>
            <a:ext cx="61722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41531F-A4C1-464D-9D0F-B6C25E5F3E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206280"/>
            <a:ext cx="61722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1200240"/>
            <a:ext cx="6172200" cy="339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55600" indent="-25560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lvl="1" marL="555480" indent="-212400"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lvl="2" marL="855720" indent="-16992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lvl="3" marL="1198440" indent="-169560"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lvl="4" marL="1541520" indent="-169920">
              <a:spcBef>
                <a:spcPts val="601"/>
              </a:spcBef>
              <a:buClr>
                <a:srgbClr val="000000"/>
              </a:buClr>
              <a:buFont typeface="Arial"/>
              <a:buChar char="»"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lvl="5" marL="1541520" indent="-169920">
              <a:spcBef>
                <a:spcPts val="601"/>
              </a:spcBef>
              <a:buClr>
                <a:srgbClr val="000000"/>
              </a:buClr>
              <a:buFont typeface="Arial"/>
              <a:buChar char="»"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lvl="6" marL="1541520" indent="-169920">
              <a:spcBef>
                <a:spcPts val="601"/>
              </a:spcBef>
              <a:buClr>
                <a:srgbClr val="000000"/>
              </a:buClr>
              <a:buFont typeface="Arial"/>
              <a:buChar char="»"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4766760"/>
            <a:ext cx="1600200" cy="2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4766760"/>
            <a:ext cx="2171520" cy="2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4766760"/>
            <a:ext cx="1600200" cy="2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D0BE7FD-1776-4570-AEEA-DBA9905DB6CF}" type="slidenum">
              <a:rPr b="0" lang="en-US" sz="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" descr=""/>
          <p:cNvPicPr/>
          <p:nvPr/>
        </p:nvPicPr>
        <p:blipFill>
          <a:blip r:embed="rId1"/>
          <a:stretch/>
        </p:blipFill>
        <p:spPr>
          <a:xfrm>
            <a:off x="743040" y="914400"/>
            <a:ext cx="2357280" cy="57168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6" descr=""/>
          <p:cNvPicPr/>
          <p:nvPr/>
        </p:nvPicPr>
        <p:blipFill>
          <a:blip r:embed="rId2"/>
          <a:stretch/>
        </p:blipFill>
        <p:spPr>
          <a:xfrm>
            <a:off x="743040" y="1486080"/>
            <a:ext cx="2357280" cy="57132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8" descr=""/>
          <p:cNvPicPr/>
          <p:nvPr/>
        </p:nvPicPr>
        <p:blipFill>
          <a:blip r:embed="rId3"/>
          <a:stretch/>
        </p:blipFill>
        <p:spPr>
          <a:xfrm>
            <a:off x="743040" y="2057400"/>
            <a:ext cx="2357280" cy="57168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10" descr=""/>
          <p:cNvPicPr/>
          <p:nvPr/>
        </p:nvPicPr>
        <p:blipFill>
          <a:blip r:embed="rId4"/>
          <a:stretch/>
        </p:blipFill>
        <p:spPr>
          <a:xfrm>
            <a:off x="743040" y="2629080"/>
            <a:ext cx="2357280" cy="57132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12" descr=""/>
          <p:cNvPicPr/>
          <p:nvPr/>
        </p:nvPicPr>
        <p:blipFill>
          <a:blip r:embed="rId5"/>
          <a:stretch/>
        </p:blipFill>
        <p:spPr>
          <a:xfrm>
            <a:off x="743040" y="3200400"/>
            <a:ext cx="2357280" cy="57168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14" descr=""/>
          <p:cNvPicPr/>
          <p:nvPr/>
        </p:nvPicPr>
        <p:blipFill>
          <a:blip r:embed="rId6"/>
          <a:stretch/>
        </p:blipFill>
        <p:spPr>
          <a:xfrm>
            <a:off x="743040" y="3772080"/>
            <a:ext cx="2357280" cy="57132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16" descr=""/>
          <p:cNvPicPr/>
          <p:nvPr/>
        </p:nvPicPr>
        <p:blipFill>
          <a:blip r:embed="rId7"/>
          <a:stretch/>
        </p:blipFill>
        <p:spPr>
          <a:xfrm>
            <a:off x="3757680" y="914400"/>
            <a:ext cx="2357280" cy="57168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18" descr=""/>
          <p:cNvPicPr/>
          <p:nvPr/>
        </p:nvPicPr>
        <p:blipFill>
          <a:blip r:embed="rId8"/>
          <a:stretch/>
        </p:blipFill>
        <p:spPr>
          <a:xfrm>
            <a:off x="3757680" y="1486080"/>
            <a:ext cx="2357280" cy="57132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20" descr=""/>
          <p:cNvPicPr/>
          <p:nvPr/>
        </p:nvPicPr>
        <p:blipFill>
          <a:blip r:embed="rId9"/>
          <a:stretch/>
        </p:blipFill>
        <p:spPr>
          <a:xfrm>
            <a:off x="3757680" y="2057400"/>
            <a:ext cx="2357280" cy="57168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22" descr=""/>
          <p:cNvPicPr/>
          <p:nvPr/>
        </p:nvPicPr>
        <p:blipFill>
          <a:blip r:embed="rId10"/>
          <a:stretch/>
        </p:blipFill>
        <p:spPr>
          <a:xfrm>
            <a:off x="3757680" y="2629080"/>
            <a:ext cx="2357280" cy="57132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24" descr=""/>
          <p:cNvPicPr/>
          <p:nvPr/>
        </p:nvPicPr>
        <p:blipFill>
          <a:blip r:embed="rId11"/>
          <a:stretch/>
        </p:blipFill>
        <p:spPr>
          <a:xfrm>
            <a:off x="3757680" y="3200400"/>
            <a:ext cx="2357280" cy="57168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26" descr=""/>
          <p:cNvPicPr/>
          <p:nvPr/>
        </p:nvPicPr>
        <p:blipFill>
          <a:blip r:embed="rId12"/>
          <a:stretch/>
        </p:blipFill>
        <p:spPr>
          <a:xfrm>
            <a:off x="3757680" y="3772080"/>
            <a:ext cx="2357280" cy="571320"/>
          </a:xfrm>
          <a:prstGeom prst="rect">
            <a:avLst/>
          </a:prstGeom>
          <a:ln w="0">
            <a:noFill/>
          </a:ln>
        </p:spPr>
      </p:pic>
      <p:sp>
        <p:nvSpPr>
          <p:cNvPr id="53" name="TextBox 27"/>
          <p:cNvSpPr/>
          <p:nvPr/>
        </p:nvSpPr>
        <p:spPr>
          <a:xfrm>
            <a:off x="329760" y="1028880"/>
            <a:ext cx="45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K=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28"/>
          <p:cNvSpPr/>
          <p:nvPr/>
        </p:nvSpPr>
        <p:spPr>
          <a:xfrm>
            <a:off x="329760" y="1585800"/>
            <a:ext cx="45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K=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29"/>
          <p:cNvSpPr/>
          <p:nvPr/>
        </p:nvSpPr>
        <p:spPr>
          <a:xfrm>
            <a:off x="329760" y="2158920"/>
            <a:ext cx="45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K=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30"/>
          <p:cNvSpPr/>
          <p:nvPr/>
        </p:nvSpPr>
        <p:spPr>
          <a:xfrm>
            <a:off x="329760" y="2730600"/>
            <a:ext cx="45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K=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31"/>
          <p:cNvSpPr/>
          <p:nvPr/>
        </p:nvSpPr>
        <p:spPr>
          <a:xfrm>
            <a:off x="329760" y="3301920"/>
            <a:ext cx="45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K=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32"/>
          <p:cNvSpPr/>
          <p:nvPr/>
        </p:nvSpPr>
        <p:spPr>
          <a:xfrm>
            <a:off x="329760" y="3860640"/>
            <a:ext cx="45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K=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33"/>
          <p:cNvSpPr/>
          <p:nvPr/>
        </p:nvSpPr>
        <p:spPr>
          <a:xfrm>
            <a:off x="3344400" y="1028880"/>
            <a:ext cx="45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K=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34"/>
          <p:cNvSpPr/>
          <p:nvPr/>
        </p:nvSpPr>
        <p:spPr>
          <a:xfrm>
            <a:off x="3344400" y="1585800"/>
            <a:ext cx="45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K=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35"/>
          <p:cNvSpPr/>
          <p:nvPr/>
        </p:nvSpPr>
        <p:spPr>
          <a:xfrm>
            <a:off x="3300840" y="2160720"/>
            <a:ext cx="541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K=1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36"/>
          <p:cNvSpPr/>
          <p:nvPr/>
        </p:nvSpPr>
        <p:spPr>
          <a:xfrm>
            <a:off x="3301200" y="2743200"/>
            <a:ext cx="541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K=1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37"/>
          <p:cNvSpPr/>
          <p:nvPr/>
        </p:nvSpPr>
        <p:spPr>
          <a:xfrm>
            <a:off x="3300840" y="3314880"/>
            <a:ext cx="541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K=1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38"/>
          <p:cNvSpPr/>
          <p:nvPr/>
        </p:nvSpPr>
        <p:spPr>
          <a:xfrm>
            <a:off x="3300840" y="3886200"/>
            <a:ext cx="541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K=1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Right Brace 39"/>
          <p:cNvSpPr/>
          <p:nvPr/>
        </p:nvSpPr>
        <p:spPr>
          <a:xfrm flipV="1" rot="16200000">
            <a:off x="960840" y="830520"/>
            <a:ext cx="57240" cy="338040"/>
          </a:xfrm>
          <a:custGeom>
            <a:avLst/>
            <a:gdLst>
              <a:gd name="textAreaLeft" fmla="*/ 0 w 57240"/>
              <a:gd name="textAreaRight" fmla="*/ 20520 w 57240"/>
              <a:gd name="textAreaTop" fmla="*/ 1440 h 338040"/>
              <a:gd name="textAreaBottom" fmla="*/ 336600 h 338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152"/>
                  <a:pt x="10800" y="303"/>
                </a:cubicBezTo>
                <a:lnTo>
                  <a:pt x="10800" y="10497"/>
                </a:lnTo>
                <a:cubicBezTo>
                  <a:pt x="10800" y="10649"/>
                  <a:pt x="16200" y="10800"/>
                  <a:pt x="21600" y="10800"/>
                </a:cubicBezTo>
                <a:cubicBezTo>
                  <a:pt x="16200" y="10800"/>
                  <a:pt x="10800" y="10952"/>
                  <a:pt x="10800" y="11103"/>
                </a:cubicBezTo>
                <a:lnTo>
                  <a:pt x="10800" y="21297"/>
                </a:lnTo>
                <a:cubicBezTo>
                  <a:pt x="10800" y="21449"/>
                  <a:pt x="5400" y="21600"/>
                  <a:pt x="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Right Brace 40"/>
          <p:cNvSpPr/>
          <p:nvPr/>
        </p:nvSpPr>
        <p:spPr>
          <a:xfrm flipV="1" rot="16200000">
            <a:off x="1294920" y="834480"/>
            <a:ext cx="57240" cy="330120"/>
          </a:xfrm>
          <a:custGeom>
            <a:avLst/>
            <a:gdLst>
              <a:gd name="textAreaLeft" fmla="*/ 0 w 57240"/>
              <a:gd name="textAreaRight" fmla="*/ 20520 w 57240"/>
              <a:gd name="textAreaTop" fmla="*/ 1440 h 330120"/>
              <a:gd name="textAreaBottom" fmla="*/ 328680 h 3301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157"/>
                  <a:pt x="10800" y="313"/>
                </a:cubicBezTo>
                <a:lnTo>
                  <a:pt x="10800" y="10487"/>
                </a:lnTo>
                <a:cubicBezTo>
                  <a:pt x="10800" y="10644"/>
                  <a:pt x="16200" y="10800"/>
                  <a:pt x="21600" y="10800"/>
                </a:cubicBezTo>
                <a:cubicBezTo>
                  <a:pt x="16200" y="10800"/>
                  <a:pt x="10800" y="10957"/>
                  <a:pt x="10800" y="11113"/>
                </a:cubicBezTo>
                <a:lnTo>
                  <a:pt x="10800" y="21287"/>
                </a:lnTo>
                <a:cubicBezTo>
                  <a:pt x="10800" y="21444"/>
                  <a:pt x="5400" y="21600"/>
                  <a:pt x="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Right Brace 41"/>
          <p:cNvSpPr/>
          <p:nvPr/>
        </p:nvSpPr>
        <p:spPr>
          <a:xfrm flipV="1" rot="16200000">
            <a:off x="1629360" y="830160"/>
            <a:ext cx="57240" cy="338400"/>
          </a:xfrm>
          <a:custGeom>
            <a:avLst/>
            <a:gdLst>
              <a:gd name="textAreaLeft" fmla="*/ 0 w 57240"/>
              <a:gd name="textAreaRight" fmla="*/ 20520 w 57240"/>
              <a:gd name="textAreaTop" fmla="*/ 1440 h 338400"/>
              <a:gd name="textAreaBottom" fmla="*/ 336960 h 3384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152"/>
                  <a:pt x="10800" y="303"/>
                </a:cubicBezTo>
                <a:lnTo>
                  <a:pt x="10800" y="10497"/>
                </a:lnTo>
                <a:cubicBezTo>
                  <a:pt x="10800" y="10649"/>
                  <a:pt x="16200" y="10800"/>
                  <a:pt x="21600" y="10800"/>
                </a:cubicBezTo>
                <a:cubicBezTo>
                  <a:pt x="16200" y="10800"/>
                  <a:pt x="10800" y="10952"/>
                  <a:pt x="10800" y="11103"/>
                </a:cubicBezTo>
                <a:lnTo>
                  <a:pt x="10800" y="21297"/>
                </a:lnTo>
                <a:cubicBezTo>
                  <a:pt x="10800" y="21449"/>
                  <a:pt x="5400" y="21600"/>
                  <a:pt x="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Right Brace 42"/>
          <p:cNvSpPr/>
          <p:nvPr/>
        </p:nvSpPr>
        <p:spPr>
          <a:xfrm flipV="1" rot="16200000">
            <a:off x="1969920" y="829440"/>
            <a:ext cx="57240" cy="339840"/>
          </a:xfrm>
          <a:custGeom>
            <a:avLst/>
            <a:gdLst>
              <a:gd name="textAreaLeft" fmla="*/ 0 w 57240"/>
              <a:gd name="textAreaRight" fmla="*/ 20520 w 57240"/>
              <a:gd name="textAreaTop" fmla="*/ 1440 h 339840"/>
              <a:gd name="textAreaBottom" fmla="*/ 338400 h 3398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152"/>
                  <a:pt x="10800" y="303"/>
                </a:cubicBezTo>
                <a:lnTo>
                  <a:pt x="10800" y="10497"/>
                </a:lnTo>
                <a:cubicBezTo>
                  <a:pt x="10800" y="10649"/>
                  <a:pt x="16200" y="10800"/>
                  <a:pt x="21600" y="10800"/>
                </a:cubicBezTo>
                <a:cubicBezTo>
                  <a:pt x="16200" y="10800"/>
                  <a:pt x="10800" y="10952"/>
                  <a:pt x="10800" y="11103"/>
                </a:cubicBezTo>
                <a:lnTo>
                  <a:pt x="10800" y="21297"/>
                </a:lnTo>
                <a:cubicBezTo>
                  <a:pt x="10800" y="21449"/>
                  <a:pt x="5400" y="21600"/>
                  <a:pt x="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Right Brace 43"/>
          <p:cNvSpPr/>
          <p:nvPr/>
        </p:nvSpPr>
        <p:spPr>
          <a:xfrm flipV="1" rot="16200000">
            <a:off x="2533680" y="838440"/>
            <a:ext cx="63360" cy="320400"/>
          </a:xfrm>
          <a:custGeom>
            <a:avLst/>
            <a:gdLst>
              <a:gd name="textAreaLeft" fmla="*/ 0 w 63360"/>
              <a:gd name="textAreaRight" fmla="*/ 22680 w 63360"/>
              <a:gd name="textAreaTop" fmla="*/ 1440 h 320400"/>
              <a:gd name="textAreaBottom" fmla="*/ 318960 h 3204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180"/>
                  <a:pt x="10800" y="360"/>
                </a:cubicBezTo>
                <a:lnTo>
                  <a:pt x="10800" y="10440"/>
                </a:lnTo>
                <a:cubicBezTo>
                  <a:pt x="10800" y="10620"/>
                  <a:pt x="16200" y="10800"/>
                  <a:pt x="21600" y="10800"/>
                </a:cubicBezTo>
                <a:cubicBezTo>
                  <a:pt x="16200" y="10800"/>
                  <a:pt x="10800" y="10980"/>
                  <a:pt x="10800" y="11160"/>
                </a:cubicBezTo>
                <a:lnTo>
                  <a:pt x="10800" y="21240"/>
                </a:lnTo>
                <a:cubicBezTo>
                  <a:pt x="10800" y="21420"/>
                  <a:pt x="5400" y="21600"/>
                  <a:pt x="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Right Brace 44"/>
          <p:cNvSpPr/>
          <p:nvPr/>
        </p:nvSpPr>
        <p:spPr>
          <a:xfrm flipV="1" rot="16200000">
            <a:off x="2184840" y="952560"/>
            <a:ext cx="65160" cy="95400"/>
          </a:xfrm>
          <a:custGeom>
            <a:avLst/>
            <a:gdLst>
              <a:gd name="textAreaLeft" fmla="*/ 0 w 65160"/>
              <a:gd name="textAreaRight" fmla="*/ 23400 w 65160"/>
              <a:gd name="textAreaTop" fmla="*/ 1440 h 95400"/>
              <a:gd name="textAreaBottom" fmla="*/ 93960 h 954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613"/>
                  <a:pt x="10800" y="1225"/>
                </a:cubicBezTo>
                <a:lnTo>
                  <a:pt x="10800" y="9575"/>
                </a:lnTo>
                <a:cubicBezTo>
                  <a:pt x="10800" y="10188"/>
                  <a:pt x="16200" y="10800"/>
                  <a:pt x="21600" y="10800"/>
                </a:cubicBezTo>
                <a:cubicBezTo>
                  <a:pt x="16200" y="10800"/>
                  <a:pt x="10800" y="11413"/>
                  <a:pt x="10800" y="12025"/>
                </a:cubicBezTo>
                <a:lnTo>
                  <a:pt x="10800" y="20375"/>
                </a:lnTo>
                <a:cubicBezTo>
                  <a:pt x="10800" y="20988"/>
                  <a:pt x="5400" y="21600"/>
                  <a:pt x="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Right Brace 45"/>
          <p:cNvSpPr/>
          <p:nvPr/>
        </p:nvSpPr>
        <p:spPr>
          <a:xfrm flipV="1" rot="16200000">
            <a:off x="2299320" y="931680"/>
            <a:ext cx="65160" cy="136800"/>
          </a:xfrm>
          <a:custGeom>
            <a:avLst/>
            <a:gdLst>
              <a:gd name="textAreaLeft" fmla="*/ 0 w 65160"/>
              <a:gd name="textAreaRight" fmla="*/ 23400 w 65160"/>
              <a:gd name="textAreaTop" fmla="*/ 1440 h 136800"/>
              <a:gd name="textAreaBottom" fmla="*/ 135360 h 1368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426"/>
                  <a:pt x="10800" y="852"/>
                </a:cubicBezTo>
                <a:lnTo>
                  <a:pt x="10800" y="9948"/>
                </a:lnTo>
                <a:cubicBezTo>
                  <a:pt x="10800" y="10374"/>
                  <a:pt x="16200" y="10800"/>
                  <a:pt x="21600" y="10800"/>
                </a:cubicBezTo>
                <a:cubicBezTo>
                  <a:pt x="16200" y="10800"/>
                  <a:pt x="10800" y="11226"/>
                  <a:pt x="10800" y="11652"/>
                </a:cubicBezTo>
                <a:lnTo>
                  <a:pt x="10800" y="20748"/>
                </a:lnTo>
                <a:cubicBezTo>
                  <a:pt x="10800" y="21174"/>
                  <a:pt x="5400" y="21600"/>
                  <a:pt x="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Right Brace 46"/>
          <p:cNvSpPr/>
          <p:nvPr/>
        </p:nvSpPr>
        <p:spPr>
          <a:xfrm flipV="1" rot="16200000">
            <a:off x="2765880" y="927000"/>
            <a:ext cx="65160" cy="146160"/>
          </a:xfrm>
          <a:custGeom>
            <a:avLst/>
            <a:gdLst>
              <a:gd name="textAreaLeft" fmla="*/ 0 w 65160"/>
              <a:gd name="textAreaRight" fmla="*/ 23400 w 65160"/>
              <a:gd name="textAreaTop" fmla="*/ 1440 h 146160"/>
              <a:gd name="textAreaBottom" fmla="*/ 144720 h 1461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398"/>
                  <a:pt x="10800" y="795"/>
                </a:cubicBezTo>
                <a:lnTo>
                  <a:pt x="10800" y="10005"/>
                </a:lnTo>
                <a:cubicBezTo>
                  <a:pt x="10800" y="10403"/>
                  <a:pt x="16200" y="10800"/>
                  <a:pt x="21600" y="10800"/>
                </a:cubicBezTo>
                <a:cubicBezTo>
                  <a:pt x="16200" y="10800"/>
                  <a:pt x="10800" y="11198"/>
                  <a:pt x="10800" y="11595"/>
                </a:cubicBezTo>
                <a:lnTo>
                  <a:pt x="10800" y="20805"/>
                </a:lnTo>
                <a:cubicBezTo>
                  <a:pt x="10800" y="21203"/>
                  <a:pt x="5400" y="21600"/>
                  <a:pt x="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Right Brace 47"/>
          <p:cNvSpPr/>
          <p:nvPr/>
        </p:nvSpPr>
        <p:spPr>
          <a:xfrm flipV="1" rot="16200000">
            <a:off x="2931840" y="909000"/>
            <a:ext cx="66600" cy="181080"/>
          </a:xfrm>
          <a:custGeom>
            <a:avLst/>
            <a:gdLst>
              <a:gd name="textAreaLeft" fmla="*/ 0 w 66600"/>
              <a:gd name="textAreaRight" fmla="*/ 24120 w 66600"/>
              <a:gd name="textAreaTop" fmla="*/ 1440 h 181080"/>
              <a:gd name="textAreaBottom" fmla="*/ 179640 h 1810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333"/>
                  <a:pt x="10800" y="666"/>
                </a:cubicBezTo>
                <a:lnTo>
                  <a:pt x="10800" y="10134"/>
                </a:lnTo>
                <a:cubicBezTo>
                  <a:pt x="10800" y="10467"/>
                  <a:pt x="16200" y="10800"/>
                  <a:pt x="21600" y="10800"/>
                </a:cubicBezTo>
                <a:cubicBezTo>
                  <a:pt x="16200" y="10800"/>
                  <a:pt x="10800" y="11133"/>
                  <a:pt x="10800" y="11466"/>
                </a:cubicBezTo>
                <a:lnTo>
                  <a:pt x="10800" y="20934"/>
                </a:lnTo>
                <a:cubicBezTo>
                  <a:pt x="10800" y="21267"/>
                  <a:pt x="5400" y="21600"/>
                  <a:pt x="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48"/>
          <p:cNvSpPr/>
          <p:nvPr/>
        </p:nvSpPr>
        <p:spPr>
          <a:xfrm>
            <a:off x="837360" y="817560"/>
            <a:ext cx="3027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Arial"/>
                <a:ea typeface="Arial"/>
              </a:rPr>
              <a:t>Typhi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49"/>
          <p:cNvSpPr/>
          <p:nvPr/>
        </p:nvSpPr>
        <p:spPr>
          <a:xfrm>
            <a:off x="1144440" y="817560"/>
            <a:ext cx="39852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Arial"/>
                <a:ea typeface="Arial"/>
              </a:rPr>
              <a:t>Enteritidis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50"/>
          <p:cNvSpPr/>
          <p:nvPr/>
        </p:nvSpPr>
        <p:spPr>
          <a:xfrm>
            <a:off x="1503000" y="817560"/>
            <a:ext cx="3207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Arial"/>
                <a:ea typeface="Arial"/>
              </a:rPr>
              <a:t>Dublin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Box 51"/>
          <p:cNvSpPr/>
          <p:nvPr/>
        </p:nvSpPr>
        <p:spPr>
          <a:xfrm>
            <a:off x="1787040" y="819000"/>
            <a:ext cx="46728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Arial"/>
                <a:ea typeface="Arial"/>
              </a:rPr>
              <a:t>Typhimurium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Box 52"/>
          <p:cNvSpPr/>
          <p:nvPr/>
        </p:nvSpPr>
        <p:spPr>
          <a:xfrm rot="16200000">
            <a:off x="1926360" y="645840"/>
            <a:ext cx="57528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Arial"/>
                <a:ea typeface="Arial"/>
              </a:rPr>
              <a:t>Biovar Gallinarum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53"/>
          <p:cNvSpPr/>
          <p:nvPr/>
        </p:nvSpPr>
        <p:spPr>
          <a:xfrm rot="16200000">
            <a:off x="2061360" y="675720"/>
            <a:ext cx="5313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Arial"/>
                <a:ea typeface="Arial"/>
              </a:rPr>
              <a:t>Biovar Pullorum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54"/>
          <p:cNvSpPr/>
          <p:nvPr/>
        </p:nvSpPr>
        <p:spPr>
          <a:xfrm>
            <a:off x="2350080" y="820800"/>
            <a:ext cx="4719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Arial"/>
                <a:ea typeface="Arial"/>
              </a:rPr>
              <a:t>Choleraesuis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Box 55"/>
          <p:cNvSpPr/>
          <p:nvPr/>
        </p:nvSpPr>
        <p:spPr>
          <a:xfrm rot="16200000">
            <a:off x="2589480" y="744840"/>
            <a:ext cx="40788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Arial"/>
                <a:ea typeface="Arial"/>
              </a:rPr>
              <a:t>Newport II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TextBox 56"/>
          <p:cNvSpPr/>
          <p:nvPr/>
        </p:nvSpPr>
        <p:spPr>
          <a:xfrm rot="16200000">
            <a:off x="2750760" y="735480"/>
            <a:ext cx="421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Arial"/>
                <a:ea typeface="Arial"/>
              </a:rPr>
              <a:t>Newport III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Right Brace 57"/>
          <p:cNvSpPr/>
          <p:nvPr/>
        </p:nvSpPr>
        <p:spPr>
          <a:xfrm flipV="1" rot="16200000">
            <a:off x="3975480" y="822960"/>
            <a:ext cx="56880" cy="338040"/>
          </a:xfrm>
          <a:custGeom>
            <a:avLst/>
            <a:gdLst>
              <a:gd name="textAreaLeft" fmla="*/ 0 w 56880"/>
              <a:gd name="textAreaRight" fmla="*/ 20520 w 56880"/>
              <a:gd name="textAreaTop" fmla="*/ 1440 h 338040"/>
              <a:gd name="textAreaBottom" fmla="*/ 336600 h 338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152"/>
                  <a:pt x="10800" y="303"/>
                </a:cubicBezTo>
                <a:lnTo>
                  <a:pt x="10800" y="10497"/>
                </a:lnTo>
                <a:cubicBezTo>
                  <a:pt x="10800" y="10649"/>
                  <a:pt x="16200" y="10800"/>
                  <a:pt x="21600" y="10800"/>
                </a:cubicBezTo>
                <a:cubicBezTo>
                  <a:pt x="16200" y="10800"/>
                  <a:pt x="10800" y="10952"/>
                  <a:pt x="10800" y="11103"/>
                </a:cubicBezTo>
                <a:lnTo>
                  <a:pt x="10800" y="21297"/>
                </a:lnTo>
                <a:cubicBezTo>
                  <a:pt x="10800" y="21449"/>
                  <a:pt x="5400" y="21600"/>
                  <a:pt x="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Right Brace 58"/>
          <p:cNvSpPr/>
          <p:nvPr/>
        </p:nvSpPr>
        <p:spPr>
          <a:xfrm flipV="1" rot="16200000">
            <a:off x="4309560" y="826920"/>
            <a:ext cx="56880" cy="330120"/>
          </a:xfrm>
          <a:custGeom>
            <a:avLst/>
            <a:gdLst>
              <a:gd name="textAreaLeft" fmla="*/ 0 w 56880"/>
              <a:gd name="textAreaRight" fmla="*/ 20520 w 56880"/>
              <a:gd name="textAreaTop" fmla="*/ 1440 h 330120"/>
              <a:gd name="textAreaBottom" fmla="*/ 328680 h 3301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157"/>
                  <a:pt x="10800" y="313"/>
                </a:cubicBezTo>
                <a:lnTo>
                  <a:pt x="10800" y="10487"/>
                </a:lnTo>
                <a:cubicBezTo>
                  <a:pt x="10800" y="10644"/>
                  <a:pt x="16200" y="10800"/>
                  <a:pt x="21600" y="10800"/>
                </a:cubicBezTo>
                <a:cubicBezTo>
                  <a:pt x="16200" y="10800"/>
                  <a:pt x="10800" y="10957"/>
                  <a:pt x="10800" y="11113"/>
                </a:cubicBezTo>
                <a:lnTo>
                  <a:pt x="10800" y="21287"/>
                </a:lnTo>
                <a:cubicBezTo>
                  <a:pt x="10800" y="21444"/>
                  <a:pt x="5400" y="21600"/>
                  <a:pt x="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Right Brace 59"/>
          <p:cNvSpPr/>
          <p:nvPr/>
        </p:nvSpPr>
        <p:spPr>
          <a:xfrm flipV="1" rot="16200000">
            <a:off x="4644360" y="822960"/>
            <a:ext cx="56880" cy="338400"/>
          </a:xfrm>
          <a:custGeom>
            <a:avLst/>
            <a:gdLst>
              <a:gd name="textAreaLeft" fmla="*/ 0 w 56880"/>
              <a:gd name="textAreaRight" fmla="*/ 20520 w 56880"/>
              <a:gd name="textAreaTop" fmla="*/ 1440 h 338400"/>
              <a:gd name="textAreaBottom" fmla="*/ 336960 h 3384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152"/>
                  <a:pt x="10800" y="303"/>
                </a:cubicBezTo>
                <a:lnTo>
                  <a:pt x="10800" y="10497"/>
                </a:lnTo>
                <a:cubicBezTo>
                  <a:pt x="10800" y="10649"/>
                  <a:pt x="16200" y="10800"/>
                  <a:pt x="21600" y="10800"/>
                </a:cubicBezTo>
                <a:cubicBezTo>
                  <a:pt x="16200" y="10800"/>
                  <a:pt x="10800" y="10952"/>
                  <a:pt x="10800" y="11103"/>
                </a:cubicBezTo>
                <a:lnTo>
                  <a:pt x="10800" y="21297"/>
                </a:lnTo>
                <a:cubicBezTo>
                  <a:pt x="10800" y="21449"/>
                  <a:pt x="5400" y="21600"/>
                  <a:pt x="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Right Brace 60"/>
          <p:cNvSpPr/>
          <p:nvPr/>
        </p:nvSpPr>
        <p:spPr>
          <a:xfrm flipV="1" rot="16200000">
            <a:off x="4984920" y="822240"/>
            <a:ext cx="56880" cy="339840"/>
          </a:xfrm>
          <a:custGeom>
            <a:avLst/>
            <a:gdLst>
              <a:gd name="textAreaLeft" fmla="*/ 0 w 56880"/>
              <a:gd name="textAreaRight" fmla="*/ 20520 w 56880"/>
              <a:gd name="textAreaTop" fmla="*/ 1440 h 339840"/>
              <a:gd name="textAreaBottom" fmla="*/ 338400 h 3398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152"/>
                  <a:pt x="10800" y="303"/>
                </a:cubicBezTo>
                <a:lnTo>
                  <a:pt x="10800" y="10497"/>
                </a:lnTo>
                <a:cubicBezTo>
                  <a:pt x="10800" y="10649"/>
                  <a:pt x="16200" y="10800"/>
                  <a:pt x="21600" y="10800"/>
                </a:cubicBezTo>
                <a:cubicBezTo>
                  <a:pt x="16200" y="10800"/>
                  <a:pt x="10800" y="10952"/>
                  <a:pt x="10800" y="11103"/>
                </a:cubicBezTo>
                <a:lnTo>
                  <a:pt x="10800" y="21297"/>
                </a:lnTo>
                <a:cubicBezTo>
                  <a:pt x="10800" y="21449"/>
                  <a:pt x="5400" y="21600"/>
                  <a:pt x="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Right Brace 61"/>
          <p:cNvSpPr/>
          <p:nvPr/>
        </p:nvSpPr>
        <p:spPr>
          <a:xfrm flipV="1" rot="16200000">
            <a:off x="5547240" y="830160"/>
            <a:ext cx="65160" cy="320760"/>
          </a:xfrm>
          <a:custGeom>
            <a:avLst/>
            <a:gdLst>
              <a:gd name="textAreaLeft" fmla="*/ 0 w 65160"/>
              <a:gd name="textAreaRight" fmla="*/ 23400 w 65160"/>
              <a:gd name="textAreaTop" fmla="*/ 1440 h 320760"/>
              <a:gd name="textAreaBottom" fmla="*/ 319320 h 3207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180"/>
                  <a:pt x="10800" y="360"/>
                </a:cubicBezTo>
                <a:lnTo>
                  <a:pt x="10800" y="10440"/>
                </a:lnTo>
                <a:cubicBezTo>
                  <a:pt x="10800" y="10620"/>
                  <a:pt x="16200" y="10800"/>
                  <a:pt x="21600" y="10800"/>
                </a:cubicBezTo>
                <a:cubicBezTo>
                  <a:pt x="16200" y="10800"/>
                  <a:pt x="10800" y="10980"/>
                  <a:pt x="10800" y="11160"/>
                </a:cubicBezTo>
                <a:lnTo>
                  <a:pt x="10800" y="21240"/>
                </a:lnTo>
                <a:cubicBezTo>
                  <a:pt x="10800" y="21420"/>
                  <a:pt x="5400" y="21600"/>
                  <a:pt x="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Right Brace 62"/>
          <p:cNvSpPr/>
          <p:nvPr/>
        </p:nvSpPr>
        <p:spPr>
          <a:xfrm flipV="1" rot="16200000">
            <a:off x="5200200" y="945360"/>
            <a:ext cx="63720" cy="95400"/>
          </a:xfrm>
          <a:custGeom>
            <a:avLst/>
            <a:gdLst>
              <a:gd name="textAreaLeft" fmla="*/ 0 w 63720"/>
              <a:gd name="textAreaRight" fmla="*/ 23040 w 63720"/>
              <a:gd name="textAreaTop" fmla="*/ 1440 h 95400"/>
              <a:gd name="textAreaBottom" fmla="*/ 93960 h 954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613"/>
                  <a:pt x="10800" y="1225"/>
                </a:cubicBezTo>
                <a:lnTo>
                  <a:pt x="10800" y="9575"/>
                </a:lnTo>
                <a:cubicBezTo>
                  <a:pt x="10800" y="10188"/>
                  <a:pt x="16200" y="10800"/>
                  <a:pt x="21600" y="10800"/>
                </a:cubicBezTo>
                <a:cubicBezTo>
                  <a:pt x="16200" y="10800"/>
                  <a:pt x="10800" y="11413"/>
                  <a:pt x="10800" y="12025"/>
                </a:cubicBezTo>
                <a:lnTo>
                  <a:pt x="10800" y="20375"/>
                </a:lnTo>
                <a:cubicBezTo>
                  <a:pt x="10800" y="20988"/>
                  <a:pt x="5400" y="21600"/>
                  <a:pt x="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Right Brace 63"/>
          <p:cNvSpPr/>
          <p:nvPr/>
        </p:nvSpPr>
        <p:spPr>
          <a:xfrm flipV="1" rot="16200000">
            <a:off x="5314680" y="924480"/>
            <a:ext cx="63720" cy="136800"/>
          </a:xfrm>
          <a:custGeom>
            <a:avLst/>
            <a:gdLst>
              <a:gd name="textAreaLeft" fmla="*/ 0 w 63720"/>
              <a:gd name="textAreaRight" fmla="*/ 23040 w 63720"/>
              <a:gd name="textAreaTop" fmla="*/ 1440 h 136800"/>
              <a:gd name="textAreaBottom" fmla="*/ 135360 h 1368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426"/>
                  <a:pt x="10800" y="852"/>
                </a:cubicBezTo>
                <a:lnTo>
                  <a:pt x="10800" y="9948"/>
                </a:lnTo>
                <a:cubicBezTo>
                  <a:pt x="10800" y="10374"/>
                  <a:pt x="16200" y="10800"/>
                  <a:pt x="21600" y="10800"/>
                </a:cubicBezTo>
                <a:cubicBezTo>
                  <a:pt x="16200" y="10800"/>
                  <a:pt x="10800" y="11226"/>
                  <a:pt x="10800" y="11652"/>
                </a:cubicBezTo>
                <a:lnTo>
                  <a:pt x="10800" y="20748"/>
                </a:lnTo>
                <a:cubicBezTo>
                  <a:pt x="10800" y="21174"/>
                  <a:pt x="5400" y="21600"/>
                  <a:pt x="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Right Brace 64"/>
          <p:cNvSpPr/>
          <p:nvPr/>
        </p:nvSpPr>
        <p:spPr>
          <a:xfrm flipV="1" rot="16200000">
            <a:off x="5780520" y="920880"/>
            <a:ext cx="65160" cy="145800"/>
          </a:xfrm>
          <a:custGeom>
            <a:avLst/>
            <a:gdLst>
              <a:gd name="textAreaLeft" fmla="*/ 0 w 65160"/>
              <a:gd name="textAreaRight" fmla="*/ 23400 w 65160"/>
              <a:gd name="textAreaTop" fmla="*/ 1440 h 145800"/>
              <a:gd name="textAreaBottom" fmla="*/ 144360 h 1458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398"/>
                  <a:pt x="10800" y="795"/>
                </a:cubicBezTo>
                <a:lnTo>
                  <a:pt x="10800" y="10005"/>
                </a:lnTo>
                <a:cubicBezTo>
                  <a:pt x="10800" y="10403"/>
                  <a:pt x="16200" y="10800"/>
                  <a:pt x="21600" y="10800"/>
                </a:cubicBezTo>
                <a:cubicBezTo>
                  <a:pt x="16200" y="10800"/>
                  <a:pt x="10800" y="11198"/>
                  <a:pt x="10800" y="11595"/>
                </a:cubicBezTo>
                <a:lnTo>
                  <a:pt x="10800" y="20805"/>
                </a:lnTo>
                <a:cubicBezTo>
                  <a:pt x="10800" y="21203"/>
                  <a:pt x="5400" y="21600"/>
                  <a:pt x="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Right Brace 65"/>
          <p:cNvSpPr/>
          <p:nvPr/>
        </p:nvSpPr>
        <p:spPr>
          <a:xfrm flipV="1" rot="16200000">
            <a:off x="5946120" y="901440"/>
            <a:ext cx="66960" cy="181080"/>
          </a:xfrm>
          <a:custGeom>
            <a:avLst/>
            <a:gdLst>
              <a:gd name="textAreaLeft" fmla="*/ 0 w 66960"/>
              <a:gd name="textAreaRight" fmla="*/ 24120 w 66960"/>
              <a:gd name="textAreaTop" fmla="*/ 1440 h 181080"/>
              <a:gd name="textAreaBottom" fmla="*/ 179640 h 1810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333"/>
                  <a:pt x="10800" y="666"/>
                </a:cubicBezTo>
                <a:lnTo>
                  <a:pt x="10800" y="10134"/>
                </a:lnTo>
                <a:cubicBezTo>
                  <a:pt x="10800" y="10467"/>
                  <a:pt x="16200" y="10800"/>
                  <a:pt x="21600" y="10800"/>
                </a:cubicBezTo>
                <a:cubicBezTo>
                  <a:pt x="16200" y="10800"/>
                  <a:pt x="10800" y="11133"/>
                  <a:pt x="10800" y="11466"/>
                </a:cubicBezTo>
                <a:lnTo>
                  <a:pt x="10800" y="20934"/>
                </a:lnTo>
                <a:cubicBezTo>
                  <a:pt x="10800" y="21267"/>
                  <a:pt x="5400" y="21600"/>
                  <a:pt x="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TextBox 66"/>
          <p:cNvSpPr/>
          <p:nvPr/>
        </p:nvSpPr>
        <p:spPr>
          <a:xfrm>
            <a:off x="3855960" y="811080"/>
            <a:ext cx="3027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Arial"/>
                <a:ea typeface="Arial"/>
              </a:rPr>
              <a:t>Typhi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TextBox 67"/>
          <p:cNvSpPr/>
          <p:nvPr/>
        </p:nvSpPr>
        <p:spPr>
          <a:xfrm>
            <a:off x="4142520" y="816120"/>
            <a:ext cx="39852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Arial"/>
                <a:ea typeface="Arial"/>
              </a:rPr>
              <a:t>Enteritidis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TextBox 68"/>
          <p:cNvSpPr/>
          <p:nvPr/>
        </p:nvSpPr>
        <p:spPr>
          <a:xfrm>
            <a:off x="4514760" y="811080"/>
            <a:ext cx="3207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Arial"/>
                <a:ea typeface="Arial"/>
              </a:rPr>
              <a:t>Dublin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TextBox 69"/>
          <p:cNvSpPr/>
          <p:nvPr/>
        </p:nvSpPr>
        <p:spPr>
          <a:xfrm>
            <a:off x="4801680" y="811080"/>
            <a:ext cx="46728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Arial"/>
                <a:ea typeface="Arial"/>
              </a:rPr>
              <a:t>Typhimurium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TextBox 70"/>
          <p:cNvSpPr/>
          <p:nvPr/>
        </p:nvSpPr>
        <p:spPr>
          <a:xfrm rot="16200000">
            <a:off x="5077440" y="666360"/>
            <a:ext cx="5313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Arial"/>
                <a:ea typeface="Arial"/>
              </a:rPr>
              <a:t>Biovar Pullorum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TextBox 71"/>
          <p:cNvSpPr/>
          <p:nvPr/>
        </p:nvSpPr>
        <p:spPr>
          <a:xfrm>
            <a:off x="5364720" y="814320"/>
            <a:ext cx="4719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Arial"/>
                <a:ea typeface="Arial"/>
              </a:rPr>
              <a:t>Choleraesuis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TextBox 72"/>
          <p:cNvSpPr/>
          <p:nvPr/>
        </p:nvSpPr>
        <p:spPr>
          <a:xfrm rot="16200000">
            <a:off x="5604120" y="737280"/>
            <a:ext cx="40788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Arial"/>
                <a:ea typeface="Arial"/>
              </a:rPr>
              <a:t>Newport II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TextBox 73"/>
          <p:cNvSpPr/>
          <p:nvPr/>
        </p:nvSpPr>
        <p:spPr>
          <a:xfrm rot="16200000">
            <a:off x="5765760" y="729000"/>
            <a:ext cx="4215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Arial"/>
                <a:ea typeface="Arial"/>
              </a:rPr>
              <a:t>Newport III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TextBox 74"/>
          <p:cNvSpPr/>
          <p:nvPr/>
        </p:nvSpPr>
        <p:spPr>
          <a:xfrm rot="16200000">
            <a:off x="4941360" y="637920"/>
            <a:ext cx="57528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" spc="-1" strike="noStrike">
                <a:solidFill>
                  <a:srgbClr val="000000"/>
                </a:solidFill>
                <a:latin typeface="Arial"/>
                <a:ea typeface="Arial"/>
              </a:rPr>
              <a:t>Biovar Gallinarum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TextBox 75"/>
          <p:cNvSpPr/>
          <p:nvPr/>
        </p:nvSpPr>
        <p:spPr>
          <a:xfrm>
            <a:off x="340200" y="301680"/>
            <a:ext cx="615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ig. S4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55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11-03T14:37:30Z</dcterms:created>
  <dc:creator>Thomas Kaufmann</dc:creator>
  <dc:description/>
  <dc:language>en-US</dc:language>
  <cp:lastModifiedBy>Alexey Rakov</cp:lastModifiedBy>
  <cp:lastPrinted>2018-10-15T22:13:39Z</cp:lastPrinted>
  <dcterms:modified xsi:type="dcterms:W3CDTF">2019-03-06T15:33:40Z</dcterms:modified>
  <cp:revision>233</cp:revision>
  <dc:subject/>
  <dc:title>PowerPoint Presentation</dc:title>
</cp:coreProperties>
</file>